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4" d="100"/>
          <a:sy n="74" d="100"/>
        </p:scale>
        <p:origin x="84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7869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07966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14087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24545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764223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23259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650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38344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7954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62838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44580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DEEA5-7C41-4594-A303-E2ED40CBDA50}" type="datetimeFigureOut">
              <a:rPr lang="en-ZA" smtClean="0"/>
              <a:t>2019/04/04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C8E446-9737-4EE6-822A-99B0121CB28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92793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Rectangle 25"/>
          <p:cNvSpPr/>
          <p:nvPr/>
        </p:nvSpPr>
        <p:spPr>
          <a:xfrm>
            <a:off x="2202259" y="242415"/>
            <a:ext cx="779438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ZA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DH cytotoxicity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 and C2 treated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 and A375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endParaRPr lang="en-ZA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99610" y="4868852"/>
            <a:ext cx="11178862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Lung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ancer cells (A549-ATCC CCL185) were cultured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 </a:t>
            </a:r>
            <a:r>
              <a:rPr lang="en-ZA" sz="1300" dirty="0" err="1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osewell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ark Memorial Institute 1640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medium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mplemented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ith 10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% FBS, 0.5% penicillin-streptomycin, and 0.5% amphotericin-B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ZA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elanoma cells (A375-ATCC CRL1619) were cultured in Dulbecco’s Modified Eagle’s Media with 1.2 g/L sodium carbonate, 10% FBS, </a:t>
            </a:r>
            <a:r>
              <a:rPr lang="it-IT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mM non-essential amino acids, 0.5 mM sodium pyruvate, </a:t>
            </a:r>
            <a:r>
              <a:rPr lang="en-ZA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5 </a:t>
            </a:r>
            <a:r>
              <a:rPr lang="en-ZA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ZA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-glutamine, 1% penicillin-streptomycin and 1% amphotericin-B.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Once the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ells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eached 80% confluence, they were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eeded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 a 3.5 cm</a:t>
            </a:r>
            <a:r>
              <a:rPr lang="en-ZA" sz="1300" baseline="300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2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diameter culture plates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t a concentration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of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2 x10</a:t>
            </a:r>
            <a:r>
              <a:rPr lang="en-ZA" sz="1300" baseline="300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5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(A549) 5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x 10</a:t>
            </a:r>
            <a:r>
              <a:rPr lang="en-ZA" sz="1300" baseline="300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5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(A375)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ells for experimental purposes.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The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ultures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ere incubated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at 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37</a:t>
            </a:r>
            <a:r>
              <a:rPr lang="en-ZA" sz="1300" baseline="300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o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 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with 5% CO</a:t>
            </a:r>
            <a:r>
              <a:rPr lang="en-ZA" sz="1300" baseline="-250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2</a:t>
            </a:r>
            <a:r>
              <a:rPr lang="en-ZA" sz="13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and 85% humidity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ZA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Cyto-Tox96 X assay (Anatech, </a:t>
            </a:r>
            <a:r>
              <a:rPr lang="en-ZA" sz="1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mega</a:t>
            </a:r>
            <a:r>
              <a:rPr lang="en-ZA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 400) was used to evaluate the cytotoxic activity of C1 and C2 on </a:t>
            </a:r>
            <a:r>
              <a:rPr lang="en-ZA" sz="13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549 cells.</a:t>
            </a:r>
            <a:r>
              <a:rPr lang="en-ZA" sz="1300" dirty="0" smtClean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 The cytotoxicity assay results showed both C1 and C2 were significantly induced the release of LDH from A549 and A375 cells in a dose dependant manner indicating its cytotoxicity, however these bioactive compounds found to be more toxic towards A549 lung cancer cells compared to A375 melanoma cells </a:t>
            </a:r>
            <a:endParaRPr lang="en-ZA" sz="1300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5254" y="904222"/>
            <a:ext cx="4063787" cy="3641377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43927" y="904222"/>
            <a:ext cx="4037292" cy="3590503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6089041" y="2254323"/>
            <a:ext cx="4106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endParaRPr lang="en-ZA" sz="1200" dirty="0"/>
          </a:p>
        </p:txBody>
      </p:sp>
      <p:sp>
        <p:nvSpPr>
          <p:cNvPr id="31" name="Rectangle 30"/>
          <p:cNvSpPr/>
          <p:nvPr/>
        </p:nvSpPr>
        <p:spPr>
          <a:xfrm>
            <a:off x="1091247" y="2115823"/>
            <a:ext cx="4026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endParaRPr lang="en-ZA" sz="1200" dirty="0"/>
          </a:p>
        </p:txBody>
      </p:sp>
    </p:spTree>
    <p:extLst>
      <p:ext uri="{BB962C8B-B14F-4D97-AF65-F5344CB8AC3E}">
        <p14:creationId xmlns:p14="http://schemas.microsoft.com/office/powerpoint/2010/main" val="3512639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22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ahoma</vt:lpstr>
      <vt:lpstr>Times New Roman</vt:lpstr>
      <vt:lpstr>Office Theme</vt:lpstr>
      <vt:lpstr>PowerPoint Presentation</vt:lpstr>
    </vt:vector>
  </TitlesOfParts>
  <Company>University of Johannes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, Blassan</dc:creator>
  <cp:lastModifiedBy>George, Blassan</cp:lastModifiedBy>
  <cp:revision>20</cp:revision>
  <dcterms:created xsi:type="dcterms:W3CDTF">2019-03-25T07:15:18Z</dcterms:created>
  <dcterms:modified xsi:type="dcterms:W3CDTF">2019-04-04T06:05:39Z</dcterms:modified>
</cp:coreProperties>
</file>